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F30AA3-9DFA-4BC1-9D54-25A09C973E4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E6A11A-D841-4F24-BA68-B0C57A3A0D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164B06-9B9C-4846-8D38-48A69F4C7B4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E29364-1816-4061-B94A-121F53C263A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7CBB90-F769-4618-93E3-1AA65F26C2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C93E03-20CF-482D-B255-927CC7BF55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C450D7-D6BF-4844-AEC5-87A258636B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13B624-4BD0-429E-B871-094F056A33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0C8F34-2FA0-4602-AEE2-33C524C982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FD5DEA-6E0E-4F58-8942-24A7C6843B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493F44-3925-4E08-AE3B-F3721E1783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4D0081-CC22-4187-B28C-B68FD0A4C3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A01E997-A642-408F-BEE8-2A382524DB2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1" name=""/>
          <p:cNvCxnSpPr>
            <a:stCxn id="42" idx="0"/>
          </p:cNvCxnSpPr>
          <p:nvPr/>
        </p:nvCxnSpPr>
        <p:spPr>
          <a:xfrm flipV="1">
            <a:off x="4637880" y="692280"/>
            <a:ext cx="5760" cy="5092920"/>
          </a:xfrm>
          <a:prstGeom prst="straightConnector1">
            <a:avLst/>
          </a:prstGeom>
          <a:ln w="19080">
            <a:solidFill>
              <a:srgbClr val="000000"/>
            </a:solidFill>
            <a:miter/>
          </a:ln>
        </p:spPr>
      </p:cxnSp>
      <p:sp>
        <p:nvSpPr>
          <p:cNvPr id="43" name="Text Box 9"/>
          <p:cNvSpPr/>
          <p:nvPr/>
        </p:nvSpPr>
        <p:spPr>
          <a:xfrm>
            <a:off x="763560" y="325440"/>
            <a:ext cx="3274560" cy="733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Calibri"/>
              </a:rPr>
              <a:t>hg19 reference sequenc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Calibri"/>
              </a:rPr>
              <a:t>Exonic regions from 301 BCR related ge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Calibri"/>
              </a:rPr>
              <a:t>UCSC &amp; eArra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12"/>
          <p:cNvSpPr/>
          <p:nvPr/>
        </p:nvSpPr>
        <p:spPr>
          <a:xfrm>
            <a:off x="5225760" y="325440"/>
            <a:ext cx="3056400" cy="733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Calibri"/>
              </a:rPr>
              <a:t>Genomic DNA from 10 CLL samples (PB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Calibri"/>
              </a:rPr>
              <a:t>Tumoral (B-cells)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Calibri"/>
              </a:rPr>
              <a:t>Normal (BM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15"/>
          <p:cNvSpPr/>
          <p:nvPr/>
        </p:nvSpPr>
        <p:spPr>
          <a:xfrm>
            <a:off x="2606040" y="1197000"/>
            <a:ext cx="4083840" cy="9464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Calibri"/>
              </a:rPr>
              <a:t>Library prepara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Calibri"/>
              </a:rPr>
              <a:t>Custom SureSelect Target Enrichme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Calibri"/>
              </a:rPr>
              <a:t>Target Regions: 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Calibri"/>
              </a:rPr>
              <a:t>1,36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Calibri"/>
              </a:rPr>
              <a:t> Mbp (0.04% of human genome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Calibri"/>
              </a:rPr>
              <a:t>Sequencing: Illumina Genome Analyzer (GA2) SE-36b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18"/>
          <p:cNvSpPr/>
          <p:nvPr/>
        </p:nvSpPr>
        <p:spPr>
          <a:xfrm>
            <a:off x="1806480" y="2449440"/>
            <a:ext cx="5662800" cy="9464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Calibri"/>
                <a:ea typeface="Calibri"/>
              </a:rPr>
              <a:t>Data analysi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  <a:ea typeface="Calibri"/>
              </a:rPr>
              <a:t>FASTQC for Quality Control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  <a:ea typeface="Calibri"/>
              </a:rPr>
              <a:t>BWA &amp; BFAST  for short-read alignment (GRCh37)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</a:rPr>
              <a:t>GATK v2  for recalibration, local realigning and variant call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21"/>
          <p:cNvSpPr/>
          <p:nvPr/>
        </p:nvSpPr>
        <p:spPr>
          <a:xfrm>
            <a:off x="2387520" y="3703680"/>
            <a:ext cx="4500720" cy="733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Calibri"/>
              </a:rPr>
              <a:t>Filter fo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Calibri"/>
              </a:rPr>
              <a:t>1. Known polymorphisms (dbSNP132,1000g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Calibri"/>
              </a:rPr>
              <a:t>2. Changes present in matched normal/control D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24"/>
          <p:cNvSpPr/>
          <p:nvPr/>
        </p:nvSpPr>
        <p:spPr>
          <a:xfrm>
            <a:off x="2387520" y="5784840"/>
            <a:ext cx="4500720" cy="733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  <a:ea typeface="Calibri"/>
              </a:rPr>
              <a:t>Putative variants were ranked by GATK quality score. Manual review (IGV), selection and validation by capillary sequenc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8" name=""/>
          <p:cNvCxnSpPr>
            <a:stCxn id="43" idx="3"/>
            <a:endCxn id="44" idx="1"/>
          </p:cNvCxnSpPr>
          <p:nvPr/>
        </p:nvCxnSpPr>
        <p:spPr>
          <a:xfrm>
            <a:off x="4038120" y="691920"/>
            <a:ext cx="1188000" cy="360"/>
          </a:xfrm>
          <a:prstGeom prst="straightConnector1">
            <a:avLst/>
          </a:prstGeom>
          <a:ln w="19080">
            <a:solidFill>
              <a:srgbClr val="000000"/>
            </a:solidFill>
            <a:miter/>
          </a:ln>
        </p:spPr>
      </p:cxnSp>
      <p:sp>
        <p:nvSpPr>
          <p:cNvPr id="49" name="Rectangle 1"/>
          <p:cNvSpPr/>
          <p:nvPr/>
        </p:nvSpPr>
        <p:spPr>
          <a:xfrm>
            <a:off x="2394000" y="4746600"/>
            <a:ext cx="4491000" cy="733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  <a:ea typeface="Calibri"/>
              </a:rPr>
              <a:t>Ensemble VEP to annotate mutations predicting affects protein func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  <a:ea typeface="Calibri"/>
              </a:rPr>
              <a:t>Discard </a:t>
            </a: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Calibri"/>
              </a:rPr>
              <a:t>Synonymous chang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28 CuadroTexto"/>
          <p:cNvSpPr/>
          <p:nvPr/>
        </p:nvSpPr>
        <p:spPr>
          <a:xfrm>
            <a:off x="50400" y="6450120"/>
            <a:ext cx="1104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29T10:57:42Z</dcterms:created>
  <dc:creator>huphm</dc:creator>
  <dc:description/>
  <dc:language>en-US</dc:language>
  <cp:lastModifiedBy>huphm</cp:lastModifiedBy>
  <dcterms:modified xsi:type="dcterms:W3CDTF">2012-03-21T16:16:23Z</dcterms:modified>
  <cp:revision>10</cp:revision>
  <dc:subject/>
  <dc:title>Diapositiva 1</dc:title>
</cp:coreProperties>
</file>